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4660"/>
  </p:normalViewPr>
  <p:slideViewPr>
    <p:cSldViewPr snapToGrid="0" showGuides="1">
      <p:cViewPr>
        <p:scale>
          <a:sx n="90" d="100"/>
          <a:sy n="90" d="100"/>
        </p:scale>
        <p:origin x="1810" y="-196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3F1428-CB60-19AA-138A-C73335F5B46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857250" y="1621191"/>
            <a:ext cx="5143500" cy="3448756"/>
          </a:xfrm>
        </p:spPr>
        <p:txBody>
          <a:bodyPr anchor="b"/>
          <a:lstStyle>
            <a:lvl1pPr algn="ctr">
              <a:defRPr sz="8666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D8D87DA-FDB0-6FE2-17BC-0C17F5C38C1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3467"/>
            </a:lvl1pPr>
            <a:lvl2pPr marL="660380" indent="0" algn="ctr">
              <a:buNone/>
              <a:defRPr sz="2889"/>
            </a:lvl2pPr>
            <a:lvl3pPr marL="1320759" indent="0" algn="ctr">
              <a:buNone/>
              <a:defRPr sz="2600"/>
            </a:lvl3pPr>
            <a:lvl4pPr marL="1981139" indent="0" algn="ctr">
              <a:buNone/>
              <a:defRPr sz="2311"/>
            </a:lvl4pPr>
            <a:lvl5pPr marL="2641519" indent="0" algn="ctr">
              <a:buNone/>
              <a:defRPr sz="2311"/>
            </a:lvl5pPr>
            <a:lvl6pPr marL="3301898" indent="0" algn="ctr">
              <a:buNone/>
              <a:defRPr sz="2311"/>
            </a:lvl6pPr>
            <a:lvl7pPr marL="3962278" indent="0" algn="ctr">
              <a:buNone/>
              <a:defRPr sz="2311"/>
            </a:lvl7pPr>
            <a:lvl8pPr marL="4622658" indent="0" algn="ctr">
              <a:buNone/>
              <a:defRPr sz="2311"/>
            </a:lvl8pPr>
            <a:lvl9pPr marL="5283037" indent="0" algn="ctr">
              <a:buNone/>
              <a:defRPr sz="2311"/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EA9BD8F-D223-40E2-532B-DE1244859B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A4458A-62DD-4F6B-A79B-9A67A13A61ED}" type="datetimeFigureOut">
              <a:rPr lang="en-IN" smtClean="0"/>
              <a:t>03-12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88BDE92-B5A7-4F44-F861-CEB087AA56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6165A5D-52A7-6528-2065-27AF5CC2ED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C49F36-4BE0-4EFB-A8C3-01C234FD9FD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323553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9B22351-407D-EAF3-5F0B-EAECB7F0C49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AC0FB98-A018-4F23-E901-FFE150A9EDB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0CB3A92-72B7-A269-576F-C3E0104C39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A4458A-62DD-4F6B-A79B-9A67A13A61ED}" type="datetimeFigureOut">
              <a:rPr lang="en-IN" smtClean="0"/>
              <a:t>03-12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6B234F2-90BA-1D84-BD24-3CDDA19CCC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18AA287-B2AB-380C-808F-C775B999D5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C49F36-4BE0-4EFB-A8C3-01C234FD9FD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5002551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50821D5-40AE-4FF3-7622-637D8C61805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4907756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2CD3935-0E48-21A4-5A3D-26D2B4CC264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471487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FE006B6-DA88-B751-C372-5CD4063395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A4458A-62DD-4F6B-A79B-9A67A13A61ED}" type="datetimeFigureOut">
              <a:rPr lang="en-IN" smtClean="0"/>
              <a:t>03-12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15524F1-5FD8-120D-5A82-50DD796E69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45D8382-6BA1-EE7B-38A3-8E6CA24736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C49F36-4BE0-4EFB-A8C3-01C234FD9FD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035041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7F517F4-BE0A-0C75-E3A8-2BD2BF07BB2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8915E80-8137-5DC4-D913-CCED38237CB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0A12256-EA5A-2415-6EDA-29D59F8296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A4458A-62DD-4F6B-A79B-9A67A13A61ED}" type="datetimeFigureOut">
              <a:rPr lang="en-IN" smtClean="0"/>
              <a:t>03-12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A068EB7-4B87-C05D-C414-C720CB02B1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30995E5-8345-9D80-A109-E68C32F76A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C49F36-4BE0-4EFB-A8C3-01C234FD9FD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7999367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666075-2D9E-4F82-2C6F-64B7A620870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67916" y="2469622"/>
            <a:ext cx="5915025" cy="4120620"/>
          </a:xfrm>
        </p:spPr>
        <p:txBody>
          <a:bodyPr anchor="b"/>
          <a:lstStyle>
            <a:lvl1pPr>
              <a:defRPr sz="8666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872D705-FEA9-8ED3-0DEB-32F1B1B69A4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67916" y="6629225"/>
            <a:ext cx="5915025" cy="2166937"/>
          </a:xfrm>
        </p:spPr>
        <p:txBody>
          <a:bodyPr/>
          <a:lstStyle>
            <a:lvl1pPr marL="0" indent="0">
              <a:buNone/>
              <a:defRPr sz="3467">
                <a:solidFill>
                  <a:schemeClr val="tx1">
                    <a:tint val="82000"/>
                  </a:schemeClr>
                </a:solidFill>
              </a:defRPr>
            </a:lvl1pPr>
            <a:lvl2pPr marL="660380" indent="0">
              <a:buNone/>
              <a:defRPr sz="2889">
                <a:solidFill>
                  <a:schemeClr val="tx1">
                    <a:tint val="82000"/>
                  </a:schemeClr>
                </a:solidFill>
              </a:defRPr>
            </a:lvl2pPr>
            <a:lvl3pPr marL="1320759" indent="0">
              <a:buNone/>
              <a:defRPr sz="2600">
                <a:solidFill>
                  <a:schemeClr val="tx1">
                    <a:tint val="82000"/>
                  </a:schemeClr>
                </a:solidFill>
              </a:defRPr>
            </a:lvl3pPr>
            <a:lvl4pPr marL="1981139" indent="0">
              <a:buNone/>
              <a:defRPr sz="2311">
                <a:solidFill>
                  <a:schemeClr val="tx1">
                    <a:tint val="82000"/>
                  </a:schemeClr>
                </a:solidFill>
              </a:defRPr>
            </a:lvl4pPr>
            <a:lvl5pPr marL="2641519" indent="0">
              <a:buNone/>
              <a:defRPr sz="2311">
                <a:solidFill>
                  <a:schemeClr val="tx1">
                    <a:tint val="82000"/>
                  </a:schemeClr>
                </a:solidFill>
              </a:defRPr>
            </a:lvl5pPr>
            <a:lvl6pPr marL="3301898" indent="0">
              <a:buNone/>
              <a:defRPr sz="2311">
                <a:solidFill>
                  <a:schemeClr val="tx1">
                    <a:tint val="82000"/>
                  </a:schemeClr>
                </a:solidFill>
              </a:defRPr>
            </a:lvl6pPr>
            <a:lvl7pPr marL="3962278" indent="0">
              <a:buNone/>
              <a:defRPr sz="2311">
                <a:solidFill>
                  <a:schemeClr val="tx1">
                    <a:tint val="82000"/>
                  </a:schemeClr>
                </a:solidFill>
              </a:defRPr>
            </a:lvl7pPr>
            <a:lvl8pPr marL="4622658" indent="0">
              <a:buNone/>
              <a:defRPr sz="2311">
                <a:solidFill>
                  <a:schemeClr val="tx1">
                    <a:tint val="82000"/>
                  </a:schemeClr>
                </a:solidFill>
              </a:defRPr>
            </a:lvl8pPr>
            <a:lvl9pPr marL="5283037" indent="0">
              <a:buNone/>
              <a:defRPr sz="2311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06334B2-2D81-A6A1-139D-4789F066EA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A4458A-62DD-4F6B-A79B-9A67A13A61ED}" type="datetimeFigureOut">
              <a:rPr lang="en-IN" smtClean="0"/>
              <a:t>03-12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0DAED5A-A282-39AB-1F99-784B1D9A17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75FDC38-90EA-B5C7-0364-9A9005104C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C49F36-4BE0-4EFB-A8C3-01C234FD9FD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9973609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794BF0-E603-7805-F008-3620F6E28F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FE12BF9-B2DE-F515-7EAA-CF28D713AAB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41C6510-5E24-906A-D018-268B889ACB6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A6FD948-4B8B-6FB6-A861-DEC493845E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A4458A-62DD-4F6B-A79B-9A67A13A61ED}" type="datetimeFigureOut">
              <a:rPr lang="en-IN" smtClean="0"/>
              <a:t>03-12-2025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44E08A9-64C4-50F4-8E4C-0EC6B51233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F450C5F-581B-50B2-93C8-C76C62E894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C49F36-4BE0-4EFB-A8C3-01C234FD9FD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8518742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C04438-A02D-96A3-87D3-0EE1A8BC38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527404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BE8FF1A-F324-B48C-53DA-B3401543889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4DF20E9-7051-4003-DDE7-462408A2E2F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6EA6E3E-C99D-E07D-484D-AF5167306B9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5A73993-0F39-0BB9-CB86-6E53BAA7BE1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994662A-AA7A-246E-3097-528AB9CF2C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A4458A-62DD-4F6B-A79B-9A67A13A61ED}" type="datetimeFigureOut">
              <a:rPr lang="en-IN" smtClean="0"/>
              <a:t>03-12-2025</a:t>
            </a:fld>
            <a:endParaRPr lang="en-I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0D1DC0D-70D4-E6A3-AE56-FC6912D979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BC52A75-1C3E-227B-E119-F6036BF981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C49F36-4BE0-4EFB-A8C3-01C234FD9FD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5686642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47BF4BF-13CE-4408-7C44-B01234A7AF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0EF8002-A07D-0E50-CD8C-4E78002730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A4458A-62DD-4F6B-A79B-9A67A13A61ED}" type="datetimeFigureOut">
              <a:rPr lang="en-IN" smtClean="0"/>
              <a:t>03-12-2025</a:t>
            </a:fld>
            <a:endParaRPr lang="en-I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243651A-B36E-AE01-8FD9-C79A29AB62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851674B-9370-6695-D69D-A0E53CBD7C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C49F36-4BE0-4EFB-A8C3-01C234FD9FD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7273489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E049A78-ADDB-0E3A-CC33-0A4B8BB1C6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A4458A-62DD-4F6B-A79B-9A67A13A61ED}" type="datetimeFigureOut">
              <a:rPr lang="en-IN" smtClean="0"/>
              <a:t>03-12-2025</a:t>
            </a:fld>
            <a:endParaRPr lang="en-I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31DED5D-E8AC-A637-A004-8396457E02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2B6BCEA-162E-609D-7563-3FE48E4BA2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C49F36-4BE0-4EFB-A8C3-01C234FD9FD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9033700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F2DF3E-5020-32E9-09EB-D8FC90CB77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9267117-0BAC-9554-27CA-42B079D6F38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>
              <a:defRPr sz="4622"/>
            </a:lvl1pPr>
            <a:lvl2pPr>
              <a:defRPr sz="4044"/>
            </a:lvl2pPr>
            <a:lvl3pPr>
              <a:defRPr sz="3467"/>
            </a:lvl3pPr>
            <a:lvl4pPr>
              <a:defRPr sz="2889"/>
            </a:lvl4pPr>
            <a:lvl5pPr>
              <a:defRPr sz="2889"/>
            </a:lvl5pPr>
            <a:lvl6pPr>
              <a:defRPr sz="2889"/>
            </a:lvl6pPr>
            <a:lvl7pPr>
              <a:defRPr sz="2889"/>
            </a:lvl7pPr>
            <a:lvl8pPr>
              <a:defRPr sz="2889"/>
            </a:lvl8pPr>
            <a:lvl9pPr>
              <a:defRPr sz="2889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60BBB18-1A6F-0388-9C1A-2BF4E019E04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E909FFB-821B-D18F-9D5B-A231050BA9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A4458A-62DD-4F6B-A79B-9A67A13A61ED}" type="datetimeFigureOut">
              <a:rPr lang="en-IN" smtClean="0"/>
              <a:t>03-12-2025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26F3BA5-4A89-3159-3186-8FE8736C26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1FEA6E8-5120-DA96-587A-26AFD0BDF4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C49F36-4BE0-4EFB-A8C3-01C234FD9FD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9430127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659DE98-A31B-7690-5274-7A1DFBDD02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6C62316-22C8-1195-EE93-807C3C100C7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 marL="0" indent="0">
              <a:buNone/>
              <a:defRPr sz="4622"/>
            </a:lvl1pPr>
            <a:lvl2pPr marL="660380" indent="0">
              <a:buNone/>
              <a:defRPr sz="4044"/>
            </a:lvl2pPr>
            <a:lvl3pPr marL="1320759" indent="0">
              <a:buNone/>
              <a:defRPr sz="3467"/>
            </a:lvl3pPr>
            <a:lvl4pPr marL="1981139" indent="0">
              <a:buNone/>
              <a:defRPr sz="2889"/>
            </a:lvl4pPr>
            <a:lvl5pPr marL="2641519" indent="0">
              <a:buNone/>
              <a:defRPr sz="2889"/>
            </a:lvl5pPr>
            <a:lvl6pPr marL="3301898" indent="0">
              <a:buNone/>
              <a:defRPr sz="2889"/>
            </a:lvl6pPr>
            <a:lvl7pPr marL="3962278" indent="0">
              <a:buNone/>
              <a:defRPr sz="2889"/>
            </a:lvl7pPr>
            <a:lvl8pPr marL="4622658" indent="0">
              <a:buNone/>
              <a:defRPr sz="2889"/>
            </a:lvl8pPr>
            <a:lvl9pPr marL="5283037" indent="0">
              <a:buNone/>
              <a:defRPr sz="2889"/>
            </a:lvl9pPr>
          </a:lstStyle>
          <a:p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3A9B9C2-6493-F4F4-9572-3027DF11991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CBACB3A-F507-C95B-6D13-DA2939B708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A4458A-62DD-4F6B-A79B-9A67A13A61ED}" type="datetimeFigureOut">
              <a:rPr lang="en-IN" smtClean="0"/>
              <a:t>03-12-2025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0026BF6-7D3F-7839-0DEC-BF3F800CB2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1559CD4-B861-611A-F1A4-BEC9FED629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C49F36-4BE0-4EFB-A8C3-01C234FD9FD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9075870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9FFAE32-9C28-9299-D0AD-CEA28DEB25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527404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6F3A4F8-A935-C3A3-89C7-BF64F24FA0B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735D3E3-BD2E-DB71-100E-BB49DD0D85D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471488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33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AA4458A-62DD-4F6B-A79B-9A67A13A61ED}" type="datetimeFigureOut">
              <a:rPr lang="en-IN" smtClean="0"/>
              <a:t>03-12-2025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FAC07D5-B3D9-BA7C-FF8B-6AD94A7D92A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271713" y="9181395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33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AD480C3-0545-9FA8-6CED-00EC7306319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843463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33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1C49F36-4BE0-4EFB-A8C3-01C234FD9FD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8188371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1320759" rtl="0" eaLnBrk="1" latinLnBrk="0" hangingPunct="1">
        <a:lnSpc>
          <a:spcPct val="90000"/>
        </a:lnSpc>
        <a:spcBef>
          <a:spcPct val="0"/>
        </a:spcBef>
        <a:buNone/>
        <a:defRPr sz="635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30190" indent="-330190" algn="l" defTabSz="1320759" rtl="0" eaLnBrk="1" latinLnBrk="0" hangingPunct="1">
        <a:lnSpc>
          <a:spcPct val="90000"/>
        </a:lnSpc>
        <a:spcBef>
          <a:spcPts val="1444"/>
        </a:spcBef>
        <a:buFont typeface="Arial" panose="020B0604020202020204" pitchFamily="34" charset="0"/>
        <a:buChar char="•"/>
        <a:defRPr sz="4044" kern="1200">
          <a:solidFill>
            <a:schemeClr val="tx1"/>
          </a:solidFill>
          <a:latin typeface="+mn-lt"/>
          <a:ea typeface="+mn-ea"/>
          <a:cs typeface="+mn-cs"/>
        </a:defRPr>
      </a:lvl1pPr>
      <a:lvl2pPr marL="990570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3467" kern="1200">
          <a:solidFill>
            <a:schemeClr val="tx1"/>
          </a:solidFill>
          <a:latin typeface="+mn-lt"/>
          <a:ea typeface="+mn-ea"/>
          <a:cs typeface="+mn-cs"/>
        </a:defRPr>
      </a:lvl2pPr>
      <a:lvl3pPr marL="165094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3pPr>
      <a:lvl4pPr marL="231132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97170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63208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429246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95284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613227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1pPr>
      <a:lvl2pPr marL="66038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32075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198113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64151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30189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27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62265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283037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925EA0A0-B04F-0B10-3731-55D3F94BABB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91462" y="690562"/>
            <a:ext cx="4875076" cy="7200000"/>
          </a:xfrm>
          <a:prstGeom prst="rect">
            <a:avLst/>
          </a:prstGeom>
        </p:spPr>
      </p:pic>
      <p:sp>
        <p:nvSpPr>
          <p:cNvPr id="4" name="TextBox 5">
            <a:extLst>
              <a:ext uri="{FF2B5EF4-FFF2-40B4-BE49-F238E27FC236}">
                <a16:creationId xmlns:a16="http://schemas.microsoft.com/office/drawing/2014/main" id="{2D5C9B66-E727-F12B-CF5C-E3AF7E80930C}"/>
              </a:ext>
            </a:extLst>
          </p:cNvPr>
          <p:cNvSpPr txBox="1"/>
          <p:nvPr/>
        </p:nvSpPr>
        <p:spPr>
          <a:xfrm>
            <a:off x="706967" y="8266611"/>
            <a:ext cx="5562600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r>
              <a:rPr lang="en-IN" sz="1000" b="1" dirty="0">
                <a:latin typeface="Palatino Linotype" panose="02040502050505030304" pitchFamily="18" charset="0"/>
                <a:cs typeface="Arial" panose="020B0604020202020204" pitchFamily="34" charset="0"/>
              </a:rPr>
              <a:t>Figure S5. </a:t>
            </a:r>
            <a:r>
              <a:rPr lang="en-IN" sz="1000" dirty="0">
                <a:latin typeface="Palatino Linotype" panose="02040502050505030304" pitchFamily="18" charset="0"/>
                <a:cs typeface="Arial" panose="020B0604020202020204" pitchFamily="34" charset="0"/>
              </a:rPr>
              <a:t>Comparison of amino acid sequences of LsTPS24. Deduced amino acid sequences from this study were aligned with that from Phytozome database.</a:t>
            </a:r>
            <a:endParaRPr lang="en-IN" sz="1000" b="1" dirty="0">
              <a:latin typeface="Palatino Linotype" panose="02040502050505030304" pitchFamily="18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390160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0</TotalTime>
  <Words>26</Words>
  <Application>Microsoft Office PowerPoint</Application>
  <PresentationFormat>A4 Paper (210x297 mm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Palatino Linotype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khileshwar Singh</dc:creator>
  <cp:lastModifiedBy>Sungbeom Lee</cp:lastModifiedBy>
  <cp:revision>9</cp:revision>
  <dcterms:created xsi:type="dcterms:W3CDTF">2025-11-12T01:08:01Z</dcterms:created>
  <dcterms:modified xsi:type="dcterms:W3CDTF">2025-12-03T03:36:52Z</dcterms:modified>
</cp:coreProperties>
</file>